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ms-powerpoint.presentation.macroEnabled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7" r:id="rId4"/>
    <p:sldId id="261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75" autoAdjust="0"/>
    <p:restoredTop sz="94660"/>
  </p:normalViewPr>
  <p:slideViewPr>
    <p:cSldViewPr snapToGrid="0">
      <p:cViewPr>
        <p:scale>
          <a:sx n="110" d="100"/>
          <a:sy n="110" d="100"/>
        </p:scale>
        <p:origin x="7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BCE70-79DC-4B49-BA51-74C29E306635}" type="datetimeFigureOut">
              <a:rPr lang="en-US" smtClean="0"/>
              <a:t>12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B7214-E632-4C98-8070-FA3116022B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952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BCE70-79DC-4B49-BA51-74C29E306635}" type="datetimeFigureOut">
              <a:rPr lang="en-US" smtClean="0"/>
              <a:t>12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B7214-E632-4C98-8070-FA3116022B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7840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BCE70-79DC-4B49-BA51-74C29E306635}" type="datetimeFigureOut">
              <a:rPr lang="en-US" smtClean="0"/>
              <a:t>12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B7214-E632-4C98-8070-FA3116022B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921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BCE70-79DC-4B49-BA51-74C29E306635}" type="datetimeFigureOut">
              <a:rPr lang="en-US" smtClean="0"/>
              <a:t>12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B7214-E632-4C98-8070-FA3116022B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91022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BCE70-79DC-4B49-BA51-74C29E306635}" type="datetimeFigureOut">
              <a:rPr lang="en-US" smtClean="0"/>
              <a:t>12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B7214-E632-4C98-8070-FA3116022B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49098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BCE70-79DC-4B49-BA51-74C29E306635}" type="datetimeFigureOut">
              <a:rPr lang="en-US" smtClean="0"/>
              <a:t>12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B7214-E632-4C98-8070-FA3116022B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2206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BCE70-79DC-4B49-BA51-74C29E306635}" type="datetimeFigureOut">
              <a:rPr lang="en-US" smtClean="0"/>
              <a:t>12/1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B7214-E632-4C98-8070-FA3116022B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46101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BCE70-79DC-4B49-BA51-74C29E306635}" type="datetimeFigureOut">
              <a:rPr lang="en-US" smtClean="0"/>
              <a:t>12/1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B7214-E632-4C98-8070-FA3116022B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2657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BCE70-79DC-4B49-BA51-74C29E306635}" type="datetimeFigureOut">
              <a:rPr lang="en-US" smtClean="0"/>
              <a:t>12/1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B7214-E632-4C98-8070-FA3116022B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61385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BCE70-79DC-4B49-BA51-74C29E306635}" type="datetimeFigureOut">
              <a:rPr lang="en-US" smtClean="0"/>
              <a:t>12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B7214-E632-4C98-8070-FA3116022B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17644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BCE70-79DC-4B49-BA51-74C29E306635}" type="datetimeFigureOut">
              <a:rPr lang="en-US" smtClean="0"/>
              <a:t>12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B7214-E632-4C98-8070-FA3116022B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57474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2BCE70-79DC-4B49-BA51-74C29E306635}" type="datetimeFigureOut">
              <a:rPr lang="en-US" smtClean="0"/>
              <a:t>12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8B7214-E632-4C98-8070-FA3116022B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71763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483538" y="2203785"/>
            <a:ext cx="3925471" cy="1975941"/>
            <a:chOff x="3016488" y="2344988"/>
            <a:chExt cx="3925471" cy="1975941"/>
          </a:xfrm>
        </p:grpSpPr>
        <p:grpSp>
          <p:nvGrpSpPr>
            <p:cNvPr id="11" name="Group 10"/>
            <p:cNvGrpSpPr/>
            <p:nvPr/>
          </p:nvGrpSpPr>
          <p:grpSpPr>
            <a:xfrm>
              <a:off x="3126659" y="2344988"/>
              <a:ext cx="2971800" cy="1452721"/>
              <a:chOff x="2927554" y="4660488"/>
              <a:chExt cx="1946788" cy="884902"/>
            </a:xfrm>
          </p:grpSpPr>
          <p:pic>
            <p:nvPicPr>
              <p:cNvPr id="6" name="Picture 5"/>
              <p:cNvPicPr>
                <a:picLocks noChangeAspect="1"/>
              </p:cNvPicPr>
              <p:nvPr/>
            </p:nvPicPr>
            <p:blipFill rotWithShape="1">
              <a:blip r:embed="rId2"/>
              <a:srcRect l="11345" t="35831" r="47464" b="57504"/>
              <a:stretch/>
            </p:blipFill>
            <p:spPr>
              <a:xfrm>
                <a:off x="2927554" y="4660488"/>
                <a:ext cx="1946788" cy="250723"/>
              </a:xfrm>
              <a:prstGeom prst="rect">
                <a:avLst/>
              </a:prstGeom>
            </p:spPr>
          </p:pic>
          <p:pic>
            <p:nvPicPr>
              <p:cNvPr id="7" name="Picture 6"/>
              <p:cNvPicPr>
                <a:picLocks noChangeAspect="1"/>
              </p:cNvPicPr>
              <p:nvPr/>
            </p:nvPicPr>
            <p:blipFill rotWithShape="1">
              <a:blip r:embed="rId3"/>
              <a:srcRect l="75084" t="61741" r="6735" b="26791"/>
              <a:stretch/>
            </p:blipFill>
            <p:spPr>
              <a:xfrm>
                <a:off x="4343400" y="4911208"/>
                <a:ext cx="530942" cy="309717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 noChangeAspect="1"/>
              </p:cNvPicPr>
              <p:nvPr/>
            </p:nvPicPr>
            <p:blipFill rotWithShape="1">
              <a:blip r:embed="rId3"/>
              <a:srcRect l="14310" t="62924" r="40236" b="27246"/>
              <a:stretch/>
            </p:blipFill>
            <p:spPr>
              <a:xfrm>
                <a:off x="2927554" y="4911209"/>
                <a:ext cx="1415845" cy="309717"/>
              </a:xfrm>
              <a:prstGeom prst="rect">
                <a:avLst/>
              </a:prstGeom>
            </p:spPr>
          </p:pic>
          <p:pic>
            <p:nvPicPr>
              <p:cNvPr id="9" name="Picture 8"/>
              <p:cNvPicPr>
                <a:picLocks noChangeAspect="1"/>
              </p:cNvPicPr>
              <p:nvPr/>
            </p:nvPicPr>
            <p:blipFill rotWithShape="1">
              <a:blip r:embed="rId3"/>
              <a:srcRect l="73990" t="45814" r="7576" b="40807"/>
              <a:stretch/>
            </p:blipFill>
            <p:spPr>
              <a:xfrm>
                <a:off x="4336025" y="5220925"/>
                <a:ext cx="538317" cy="324465"/>
              </a:xfrm>
              <a:prstGeom prst="rect">
                <a:avLst/>
              </a:prstGeom>
            </p:spPr>
          </p:pic>
          <p:pic>
            <p:nvPicPr>
              <p:cNvPr id="10" name="Picture 9"/>
              <p:cNvPicPr>
                <a:picLocks noChangeAspect="1"/>
              </p:cNvPicPr>
              <p:nvPr/>
            </p:nvPicPr>
            <p:blipFill rotWithShape="1">
              <a:blip r:embed="rId3"/>
              <a:srcRect l="14732" t="46450" r="39815" b="41536"/>
              <a:stretch/>
            </p:blipFill>
            <p:spPr>
              <a:xfrm>
                <a:off x="2927555" y="5220925"/>
                <a:ext cx="1415845" cy="324465"/>
              </a:xfrm>
              <a:prstGeom prst="rect">
                <a:avLst/>
              </a:prstGeom>
            </p:spPr>
          </p:pic>
        </p:grpSp>
        <p:sp>
          <p:nvSpPr>
            <p:cNvPr id="12" name="TextBox 11"/>
            <p:cNvSpPr txBox="1"/>
            <p:nvPr/>
          </p:nvSpPr>
          <p:spPr>
            <a:xfrm>
              <a:off x="6098458" y="2415900"/>
              <a:ext cx="843501" cy="11695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GC-1</a:t>
              </a:r>
              <a:r>
                <a:rPr lang="el-G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4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4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UCP1</a:t>
              </a:r>
            </a:p>
            <a:p>
              <a:endParaRPr lang="en-US" sz="14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016488" y="3814397"/>
              <a:ext cx="8185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794015" y="3797709"/>
              <a:ext cx="78579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N</a:t>
              </a:r>
            </a:p>
            <a:p>
              <a:pPr algn="ctr"/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.25µM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589745" y="3782949"/>
              <a:ext cx="63671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N</a:t>
              </a:r>
            </a:p>
            <a:p>
              <a:pPr algn="ctr"/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µM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388468" y="3782938"/>
              <a:ext cx="63671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so</a:t>
              </a:r>
              <a:endParaRPr lang="en-US" sz="14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µM</a:t>
              </a:r>
            </a:p>
          </p:txBody>
        </p:sp>
      </p:grpSp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23264" y="689737"/>
            <a:ext cx="4457700" cy="287655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31010" y="3767826"/>
            <a:ext cx="2914650" cy="2695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050787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455792" y="454192"/>
            <a:ext cx="3658558" cy="2410232"/>
            <a:chOff x="1902037" y="1769808"/>
            <a:chExt cx="3658558" cy="2410232"/>
          </a:xfrm>
        </p:grpSpPr>
        <p:grpSp>
          <p:nvGrpSpPr>
            <p:cNvPr id="9" name="Group 8"/>
            <p:cNvGrpSpPr/>
            <p:nvPr/>
          </p:nvGrpSpPr>
          <p:grpSpPr>
            <a:xfrm>
              <a:off x="1983657" y="1769808"/>
              <a:ext cx="2817225" cy="1806676"/>
              <a:chOff x="2605393" y="1769807"/>
              <a:chExt cx="1914988" cy="1666567"/>
            </a:xfrm>
          </p:grpSpPr>
          <p:grpSp>
            <p:nvGrpSpPr>
              <p:cNvPr id="5" name="Group 4"/>
              <p:cNvGrpSpPr/>
              <p:nvPr/>
            </p:nvGrpSpPr>
            <p:grpSpPr>
              <a:xfrm>
                <a:off x="2605393" y="2728452"/>
                <a:ext cx="1914988" cy="707922"/>
                <a:chOff x="2605393" y="2728452"/>
                <a:chExt cx="1914988" cy="707922"/>
              </a:xfrm>
            </p:grpSpPr>
            <p:pic>
              <p:nvPicPr>
                <p:cNvPr id="2" name="Picture 1"/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40673" t="36065" r="48022" b="35260"/>
                <a:stretch/>
              </p:blipFill>
              <p:spPr>
                <a:xfrm>
                  <a:off x="4033684" y="2728452"/>
                  <a:ext cx="486697" cy="707922"/>
                </a:xfrm>
                <a:prstGeom prst="rect">
                  <a:avLst/>
                </a:prstGeom>
              </p:spPr>
            </p:pic>
            <p:pic>
              <p:nvPicPr>
                <p:cNvPr id="3" name="Picture 2"/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19806" t="36948" r="59064" b="34356"/>
                <a:stretch/>
              </p:blipFill>
              <p:spPr>
                <a:xfrm>
                  <a:off x="3134032" y="2728452"/>
                  <a:ext cx="899652" cy="707922"/>
                </a:xfrm>
                <a:prstGeom prst="rect">
                  <a:avLst/>
                </a:prstGeom>
              </p:spPr>
            </p:pic>
            <p:pic>
              <p:nvPicPr>
                <p:cNvPr id="4" name="Picture 3"/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51212" t="36328" r="36372" b="36028"/>
                <a:stretch/>
              </p:blipFill>
              <p:spPr>
                <a:xfrm>
                  <a:off x="2605393" y="2728452"/>
                  <a:ext cx="528639" cy="707922"/>
                </a:xfrm>
                <a:prstGeom prst="rect">
                  <a:avLst/>
                </a:prstGeom>
              </p:spPr>
            </p:pic>
          </p:grpSp>
          <p:pic>
            <p:nvPicPr>
              <p:cNvPr id="7" name="Picture 6"/>
              <p:cNvPicPr>
                <a:picLocks noChangeAspect="1"/>
              </p:cNvPicPr>
              <p:nvPr/>
            </p:nvPicPr>
            <p:blipFill rotWithShape="1">
              <a:blip r:embed="rId3"/>
              <a:srcRect l="2407" t="24801" r="3269" b="23121"/>
              <a:stretch/>
            </p:blipFill>
            <p:spPr>
              <a:xfrm>
                <a:off x="2605393" y="2271252"/>
                <a:ext cx="1914988" cy="457200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 noChangeAspect="1"/>
              </p:cNvPicPr>
              <p:nvPr/>
            </p:nvPicPr>
            <p:blipFill rotWithShape="1">
              <a:blip r:embed="rId4"/>
              <a:srcRect l="12564" t="35104" r="51538" b="51568"/>
              <a:stretch/>
            </p:blipFill>
            <p:spPr>
              <a:xfrm>
                <a:off x="2605393" y="1769807"/>
                <a:ext cx="1914988" cy="501445"/>
              </a:xfrm>
              <a:prstGeom prst="rect">
                <a:avLst/>
              </a:prstGeom>
            </p:spPr>
          </p:pic>
        </p:grpSp>
        <p:sp>
          <p:nvSpPr>
            <p:cNvPr id="10" name="TextBox 9"/>
            <p:cNvSpPr txBox="1"/>
            <p:nvPr/>
          </p:nvSpPr>
          <p:spPr>
            <a:xfrm>
              <a:off x="4757170" y="1887795"/>
              <a:ext cx="803425" cy="16004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BX-1</a:t>
              </a:r>
            </a:p>
            <a:p>
              <a:endParaRPr lang="en-US" sz="14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IDE-A</a:t>
              </a:r>
            </a:p>
            <a:p>
              <a:endParaRPr lang="en-US" sz="14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ZIC1</a:t>
              </a:r>
            </a:p>
            <a:p>
              <a:endParaRPr lang="en-US" sz="14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</a:p>
          </p:txBody>
        </p:sp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902037" y="3576484"/>
              <a:ext cx="3042168" cy="603556"/>
            </a:xfrm>
            <a:prstGeom prst="rect">
              <a:avLst/>
            </a:prstGeom>
          </p:spPr>
        </p:pic>
      </p:grpSp>
      <p:pic>
        <p:nvPicPr>
          <p:cNvPr id="13" name="Picture 1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493768" y="357051"/>
            <a:ext cx="4325301" cy="3181553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19019" y="3146217"/>
            <a:ext cx="3795331" cy="2829655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395368" y="3702095"/>
            <a:ext cx="4257675" cy="24669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269143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5978252" y="1715588"/>
            <a:ext cx="5758936" cy="2732899"/>
            <a:chOff x="5272858" y="2090057"/>
            <a:chExt cx="5758936" cy="2732899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2"/>
            <a:srcRect l="8351" t="38429" r="34003" b="50159"/>
            <a:stretch/>
          </p:blipFill>
          <p:spPr>
            <a:xfrm>
              <a:off x="6397546" y="3094211"/>
              <a:ext cx="3018452" cy="559194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3"/>
            <a:srcRect l="11992" t="20694" r="29821" b="63359"/>
            <a:stretch/>
          </p:blipFill>
          <p:spPr>
            <a:xfrm>
              <a:off x="6397546" y="2596197"/>
              <a:ext cx="3018452" cy="498013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9549882" y="2249884"/>
              <a:ext cx="869853" cy="1169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SL</a:t>
              </a:r>
            </a:p>
            <a:p>
              <a:pPr algn="ctr"/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GL</a:t>
              </a:r>
            </a:p>
            <a:p>
              <a:pPr algn="ctr"/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272858" y="3653405"/>
              <a:ext cx="5758936" cy="1169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Xanthohumol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-        +        -        +        -        +		</a:t>
              </a:r>
            </a:p>
            <a:p>
              <a:endParaRPr lang="en-US" sz="14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Dorsomorphin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-        -         +       +        -         -</a:t>
              </a:r>
            </a:p>
            <a:p>
              <a:endParaRPr lang="en-US" sz="14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ICAR                 -        -         -         -        +        +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4"/>
            <a:srcRect l="43090" t="18814" r="20650" b="60335"/>
            <a:stretch/>
          </p:blipFill>
          <p:spPr>
            <a:xfrm>
              <a:off x="6397546" y="2090057"/>
              <a:ext cx="3018452" cy="533049"/>
            </a:xfrm>
            <a:prstGeom prst="rect">
              <a:avLst/>
            </a:prstGeom>
          </p:spPr>
        </p:pic>
      </p:grp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1016" y="1281680"/>
            <a:ext cx="4914900" cy="2371725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2212" y="3853702"/>
            <a:ext cx="4308132" cy="2619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259952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57845" y="3569154"/>
            <a:ext cx="4381500" cy="241935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6022" y="855694"/>
            <a:ext cx="4876800" cy="2131346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36735" y="3978458"/>
            <a:ext cx="4448175" cy="2505075"/>
          </a:xfrm>
          <a:prstGeom prst="rect">
            <a:avLst/>
          </a:prstGeom>
        </p:spPr>
      </p:pic>
      <p:grpSp>
        <p:nvGrpSpPr>
          <p:cNvPr id="15" name="Group 14"/>
          <p:cNvGrpSpPr/>
          <p:nvPr/>
        </p:nvGrpSpPr>
        <p:grpSpPr>
          <a:xfrm>
            <a:off x="6244046" y="596556"/>
            <a:ext cx="5319698" cy="2233730"/>
            <a:chOff x="5639345" y="953607"/>
            <a:chExt cx="5758936" cy="2909266"/>
          </a:xfrm>
        </p:grpSpPr>
        <p:grpSp>
          <p:nvGrpSpPr>
            <p:cNvPr id="12" name="Group 11"/>
            <p:cNvGrpSpPr/>
            <p:nvPr/>
          </p:nvGrpSpPr>
          <p:grpSpPr>
            <a:xfrm>
              <a:off x="7053941" y="976586"/>
              <a:ext cx="2708369" cy="1595845"/>
              <a:chOff x="7010399" y="1495697"/>
              <a:chExt cx="2708369" cy="1595845"/>
            </a:xfrm>
          </p:grpSpPr>
          <p:pic>
            <p:nvPicPr>
              <p:cNvPr id="3" name="Picture 2"/>
              <p:cNvPicPr>
                <a:picLocks noChangeAspect="1"/>
              </p:cNvPicPr>
              <p:nvPr/>
            </p:nvPicPr>
            <p:blipFill rotWithShape="1">
              <a:blip r:embed="rId4"/>
              <a:srcRect l="11489" t="40328" r="28212" b="50285"/>
              <a:stretch/>
            </p:blipFill>
            <p:spPr>
              <a:xfrm>
                <a:off x="7010400" y="1915886"/>
                <a:ext cx="2708367" cy="357051"/>
              </a:xfrm>
              <a:prstGeom prst="rect">
                <a:avLst/>
              </a:prstGeom>
            </p:spPr>
          </p:pic>
          <p:pic>
            <p:nvPicPr>
              <p:cNvPr id="6" name="Picture 5"/>
              <p:cNvPicPr>
                <a:picLocks noChangeAspect="1"/>
              </p:cNvPicPr>
              <p:nvPr/>
            </p:nvPicPr>
            <p:blipFill rotWithShape="1">
              <a:blip r:embed="rId2"/>
              <a:srcRect l="10944" t="31192" r="27243" b="34972"/>
              <a:stretch/>
            </p:blipFill>
            <p:spPr>
              <a:xfrm>
                <a:off x="7010401" y="2272937"/>
                <a:ext cx="2708367" cy="818605"/>
              </a:xfrm>
              <a:prstGeom prst="rect">
                <a:avLst/>
              </a:prstGeom>
            </p:spPr>
          </p:pic>
          <p:pic>
            <p:nvPicPr>
              <p:cNvPr id="10" name="Picture 9"/>
              <p:cNvPicPr>
                <a:picLocks noChangeAspect="1"/>
              </p:cNvPicPr>
              <p:nvPr/>
            </p:nvPicPr>
            <p:blipFill rotWithShape="1">
              <a:blip r:embed="rId3"/>
              <a:srcRect l="45446" t="52399" r="17233" b="33300"/>
              <a:stretch/>
            </p:blipFill>
            <p:spPr>
              <a:xfrm>
                <a:off x="7010399" y="1495697"/>
                <a:ext cx="2708368" cy="483327"/>
              </a:xfrm>
              <a:prstGeom prst="rect">
                <a:avLst/>
              </a:prstGeom>
            </p:spPr>
          </p:pic>
        </p:grpSp>
        <p:sp>
          <p:nvSpPr>
            <p:cNvPr id="13" name="TextBox 12"/>
            <p:cNvSpPr txBox="1"/>
            <p:nvPr/>
          </p:nvSpPr>
          <p:spPr>
            <a:xfrm>
              <a:off x="5639345" y="2693322"/>
              <a:ext cx="5758936" cy="1169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Xanthohumol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-        +        -        +        -        +		</a:t>
              </a:r>
            </a:p>
            <a:p>
              <a:endParaRPr lang="en-US" sz="14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Dorsomorphin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-        -         +       +        -         -</a:t>
              </a:r>
            </a:p>
            <a:p>
              <a:endParaRPr lang="en-US" sz="14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ICAR                 -        -         -         -        +        +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9762309" y="953607"/>
              <a:ext cx="881973" cy="16004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UCP1</a:t>
              </a:r>
            </a:p>
            <a:p>
              <a:endParaRPr lang="en-US" sz="14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MPK</a:t>
              </a:r>
            </a:p>
            <a:p>
              <a:endParaRPr lang="en-US" sz="14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-AMPK</a:t>
              </a:r>
            </a:p>
            <a:p>
              <a:endParaRPr lang="en-US" sz="14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174698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017</TotalTime>
  <Words>36</Words>
  <Application>Microsoft Office PowerPoint</Application>
  <PresentationFormat>Widescreen</PresentationFormat>
  <Paragraphs>41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Philadelphia College of Osteopathic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aiya Samuels</dc:creator>
  <cp:lastModifiedBy>Janaiya Samuels</cp:lastModifiedBy>
  <cp:revision>15</cp:revision>
  <dcterms:created xsi:type="dcterms:W3CDTF">2017-11-16T21:58:34Z</dcterms:created>
  <dcterms:modified xsi:type="dcterms:W3CDTF">2017-12-17T20:52:45Z</dcterms:modified>
</cp:coreProperties>
</file>